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42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49D9A50-FADE-8342-9437-210282157338}" v="863" dt="2025-01-18T14:10:35.24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423" autoAdjust="0"/>
    <p:restoredTop sz="78239"/>
  </p:normalViewPr>
  <p:slideViewPr>
    <p:cSldViewPr snapToGrid="0">
      <p:cViewPr varScale="1">
        <p:scale>
          <a:sx n="95" d="100"/>
          <a:sy n="95" d="100"/>
        </p:scale>
        <p:origin x="17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medeo Chiribiri" userId="868f9d26-4d40-4615-9aea-e37957f3ff01" providerId="ADAL" clId="{FCD576E3-6FB7-8546-911F-516AE60F29A0}"/>
    <pc:docChg chg="delSld">
      <pc:chgData name="Amedeo Chiribiri" userId="868f9d26-4d40-4615-9aea-e37957f3ff01" providerId="ADAL" clId="{FCD576E3-6FB7-8546-911F-516AE60F29A0}" dt="2025-01-18T15:14:11.412" v="0" actId="2696"/>
      <pc:docMkLst>
        <pc:docMk/>
      </pc:docMkLst>
      <pc:sldChg chg="del">
        <pc:chgData name="Amedeo Chiribiri" userId="868f9d26-4d40-4615-9aea-e37957f3ff01" providerId="ADAL" clId="{FCD576E3-6FB7-8546-911F-516AE60F29A0}" dt="2025-01-18T15:14:11.412" v="0" actId="2696"/>
        <pc:sldMkLst>
          <pc:docMk/>
          <pc:sldMk cId="2773818052" sldId="423"/>
        </pc:sldMkLst>
      </pc:sldChg>
    </pc:docChg>
  </pc:docChgLst>
  <pc:docChgLst>
    <pc:chgData name="Amedeo Chiribiri" userId="868f9d26-4d40-4615-9aea-e37957f3ff01" providerId="ADAL" clId="{449D9A50-FADE-8342-9437-210282157338}"/>
    <pc:docChg chg="custSel addSld delSld modSld">
      <pc:chgData name="Amedeo Chiribiri" userId="868f9d26-4d40-4615-9aea-e37957f3ff01" providerId="ADAL" clId="{449D9A50-FADE-8342-9437-210282157338}" dt="2025-01-18T14:10:35.248" v="184" actId="18331"/>
      <pc:docMkLst>
        <pc:docMk/>
      </pc:docMkLst>
      <pc:sldChg chg="del">
        <pc:chgData name="Amedeo Chiribiri" userId="868f9d26-4d40-4615-9aea-e37957f3ff01" providerId="ADAL" clId="{449D9A50-FADE-8342-9437-210282157338}" dt="2025-01-13T19:51:19.851" v="0" actId="2696"/>
        <pc:sldMkLst>
          <pc:docMk/>
          <pc:sldMk cId="3374773162" sldId="281"/>
        </pc:sldMkLst>
      </pc:sldChg>
      <pc:sldChg chg="del">
        <pc:chgData name="Amedeo Chiribiri" userId="868f9d26-4d40-4615-9aea-e37957f3ff01" providerId="ADAL" clId="{449D9A50-FADE-8342-9437-210282157338}" dt="2025-01-13T19:51:19.938" v="10" actId="2696"/>
        <pc:sldMkLst>
          <pc:docMk/>
          <pc:sldMk cId="943153212" sldId="410"/>
        </pc:sldMkLst>
      </pc:sldChg>
      <pc:sldChg chg="del">
        <pc:chgData name="Amedeo Chiribiri" userId="868f9d26-4d40-4615-9aea-e37957f3ff01" providerId="ADAL" clId="{449D9A50-FADE-8342-9437-210282157338}" dt="2025-01-13T19:51:19.861" v="5" actId="2696"/>
        <pc:sldMkLst>
          <pc:docMk/>
          <pc:sldMk cId="1691788399" sldId="417"/>
        </pc:sldMkLst>
      </pc:sldChg>
      <pc:sldChg chg="del">
        <pc:chgData name="Amedeo Chiribiri" userId="868f9d26-4d40-4615-9aea-e37957f3ff01" providerId="ADAL" clId="{449D9A50-FADE-8342-9437-210282157338}" dt="2025-01-13T19:51:19.864" v="6" actId="2696"/>
        <pc:sldMkLst>
          <pc:docMk/>
          <pc:sldMk cId="2362875363" sldId="418"/>
        </pc:sldMkLst>
      </pc:sldChg>
      <pc:sldChg chg="del">
        <pc:chgData name="Amedeo Chiribiri" userId="868f9d26-4d40-4615-9aea-e37957f3ff01" providerId="ADAL" clId="{449D9A50-FADE-8342-9437-210282157338}" dt="2025-01-13T19:51:19.858" v="2" actId="2696"/>
        <pc:sldMkLst>
          <pc:docMk/>
          <pc:sldMk cId="1235698215" sldId="421"/>
        </pc:sldMkLst>
      </pc:sldChg>
      <pc:sldChg chg="addSp delSp modSp mod">
        <pc:chgData name="Amedeo Chiribiri" userId="868f9d26-4d40-4615-9aea-e37957f3ff01" providerId="ADAL" clId="{449D9A50-FADE-8342-9437-210282157338}" dt="2025-01-16T18:09:14.709" v="157" actId="20577"/>
        <pc:sldMkLst>
          <pc:docMk/>
          <pc:sldMk cId="2773818052" sldId="423"/>
        </pc:sldMkLst>
      </pc:sldChg>
      <pc:sldChg chg="addSp delSp modSp add mod delAnim modAnim">
        <pc:chgData name="Amedeo Chiribiri" userId="868f9d26-4d40-4615-9aea-e37957f3ff01" providerId="ADAL" clId="{449D9A50-FADE-8342-9437-210282157338}" dt="2025-01-18T14:10:35.248" v="184" actId="18331"/>
        <pc:sldMkLst>
          <pc:docMk/>
          <pc:sldMk cId="3764803325" sldId="424"/>
        </pc:sldMkLst>
        <pc:spChg chg="add mod">
          <ac:chgData name="Amedeo Chiribiri" userId="868f9d26-4d40-4615-9aea-e37957f3ff01" providerId="ADAL" clId="{449D9A50-FADE-8342-9437-210282157338}" dt="2025-01-18T14:08:47.193" v="183"/>
          <ac:spMkLst>
            <pc:docMk/>
            <pc:sldMk cId="3764803325" sldId="424"/>
            <ac:spMk id="7" creationId="{2FF19400-5582-5197-4EB7-FF9CDA172C64}"/>
          </ac:spMkLst>
        </pc:spChg>
        <pc:spChg chg="mod">
          <ac:chgData name="Amedeo Chiribiri" userId="868f9d26-4d40-4615-9aea-e37957f3ff01" providerId="ADAL" clId="{449D9A50-FADE-8342-9437-210282157338}" dt="2025-01-18T14:08:12.753" v="172" actId="1037"/>
          <ac:spMkLst>
            <pc:docMk/>
            <pc:sldMk cId="3764803325" sldId="424"/>
            <ac:spMk id="8" creationId="{433D5234-ECC9-EB9F-0C79-6BB74FFCA613}"/>
          </ac:spMkLst>
        </pc:spChg>
        <pc:spChg chg="mod">
          <ac:chgData name="Amedeo Chiribiri" userId="868f9d26-4d40-4615-9aea-e37957f3ff01" providerId="ADAL" clId="{449D9A50-FADE-8342-9437-210282157338}" dt="2025-01-18T14:08:12.753" v="172" actId="1037"/>
          <ac:spMkLst>
            <pc:docMk/>
            <pc:sldMk cId="3764803325" sldId="424"/>
            <ac:spMk id="9" creationId="{A93FD169-2199-3ED3-FC9B-3141D113542E}"/>
          </ac:spMkLst>
        </pc:spChg>
        <pc:spChg chg="mod">
          <ac:chgData name="Amedeo Chiribiri" userId="868f9d26-4d40-4615-9aea-e37957f3ff01" providerId="ADAL" clId="{449D9A50-FADE-8342-9437-210282157338}" dt="2025-01-18T14:08:12.753" v="172" actId="1037"/>
          <ac:spMkLst>
            <pc:docMk/>
            <pc:sldMk cId="3764803325" sldId="424"/>
            <ac:spMk id="23" creationId="{DBF06B0A-5322-134D-382D-6539431EAC3A}"/>
          </ac:spMkLst>
        </pc:spChg>
        <pc:spChg chg="mod">
          <ac:chgData name="Amedeo Chiribiri" userId="868f9d26-4d40-4615-9aea-e37957f3ff01" providerId="ADAL" clId="{449D9A50-FADE-8342-9437-210282157338}" dt="2025-01-18T14:08:12.753" v="172" actId="1037"/>
          <ac:spMkLst>
            <pc:docMk/>
            <pc:sldMk cId="3764803325" sldId="424"/>
            <ac:spMk id="24" creationId="{80F8DEBE-F9E0-CAB6-7359-756583983A6B}"/>
          </ac:spMkLst>
        </pc:spChg>
        <pc:spChg chg="mod">
          <ac:chgData name="Amedeo Chiribiri" userId="868f9d26-4d40-4615-9aea-e37957f3ff01" providerId="ADAL" clId="{449D9A50-FADE-8342-9437-210282157338}" dt="2025-01-18T14:08:12.753" v="172" actId="1037"/>
          <ac:spMkLst>
            <pc:docMk/>
            <pc:sldMk cId="3764803325" sldId="424"/>
            <ac:spMk id="25" creationId="{ECEB013D-1CE2-4C47-0530-B8FB7AC7F7C0}"/>
          </ac:spMkLst>
        </pc:spChg>
        <pc:spChg chg="mod">
          <ac:chgData name="Amedeo Chiribiri" userId="868f9d26-4d40-4615-9aea-e37957f3ff01" providerId="ADAL" clId="{449D9A50-FADE-8342-9437-210282157338}" dt="2025-01-18T14:08:28.150" v="180" actId="20577"/>
          <ac:spMkLst>
            <pc:docMk/>
            <pc:sldMk cId="3764803325" sldId="424"/>
            <ac:spMk id="26" creationId="{A7659C51-19A9-0D99-A43C-902AEB1DFE1E}"/>
          </ac:spMkLst>
        </pc:spChg>
        <pc:picChg chg="add mod">
          <ac:chgData name="Amedeo Chiribiri" userId="868f9d26-4d40-4615-9aea-e37957f3ff01" providerId="ADAL" clId="{449D9A50-FADE-8342-9437-210282157338}" dt="2025-01-18T14:08:47.193" v="183"/>
          <ac:picMkLst>
            <pc:docMk/>
            <pc:sldMk cId="3764803325" sldId="424"/>
            <ac:picMk id="2" creationId="{0836B2EE-462B-D634-5AA8-7128AEBB2897}"/>
          </ac:picMkLst>
        </pc:picChg>
        <pc:picChg chg="del mod">
          <ac:chgData name="Amedeo Chiribiri" userId="868f9d26-4d40-4615-9aea-e37957f3ff01" providerId="ADAL" clId="{449D9A50-FADE-8342-9437-210282157338}" dt="2025-01-18T14:08:35.871" v="181" actId="478"/>
          <ac:picMkLst>
            <pc:docMk/>
            <pc:sldMk cId="3764803325" sldId="424"/>
            <ac:picMk id="3" creationId="{638423FC-8D70-D627-E34F-80237B5DF49C}"/>
          </ac:picMkLst>
        </pc:picChg>
        <pc:picChg chg="del">
          <ac:chgData name="Amedeo Chiribiri" userId="868f9d26-4d40-4615-9aea-e37957f3ff01" providerId="ADAL" clId="{449D9A50-FADE-8342-9437-210282157338}" dt="2025-01-18T14:08:35.871" v="181" actId="478"/>
          <ac:picMkLst>
            <pc:docMk/>
            <pc:sldMk cId="3764803325" sldId="424"/>
            <ac:picMk id="4" creationId="{F527DA3E-AE96-0579-C977-C8A029055526}"/>
          </ac:picMkLst>
        </pc:picChg>
        <pc:picChg chg="del">
          <ac:chgData name="Amedeo Chiribiri" userId="868f9d26-4d40-4615-9aea-e37957f3ff01" providerId="ADAL" clId="{449D9A50-FADE-8342-9437-210282157338}" dt="2025-01-18T14:08:35.871" v="181" actId="478"/>
          <ac:picMkLst>
            <pc:docMk/>
            <pc:sldMk cId="3764803325" sldId="424"/>
            <ac:picMk id="5" creationId="{7403265E-7B4B-9F7C-388A-E60E3E4E4F4B}"/>
          </ac:picMkLst>
        </pc:picChg>
        <pc:picChg chg="del mod">
          <ac:chgData name="Amedeo Chiribiri" userId="868f9d26-4d40-4615-9aea-e37957f3ff01" providerId="ADAL" clId="{449D9A50-FADE-8342-9437-210282157338}" dt="2025-01-18T14:08:38.405" v="182" actId="478"/>
          <ac:picMkLst>
            <pc:docMk/>
            <pc:sldMk cId="3764803325" sldId="424"/>
            <ac:picMk id="6" creationId="{E118B0D2-E69B-C9ED-4762-497CF87370A7}"/>
          </ac:picMkLst>
        </pc:picChg>
        <pc:picChg chg="mod">
          <ac:chgData name="Amedeo Chiribiri" userId="868f9d26-4d40-4615-9aea-e37957f3ff01" providerId="ADAL" clId="{449D9A50-FADE-8342-9437-210282157338}" dt="2025-01-18T14:08:12.753" v="172" actId="1037"/>
          <ac:picMkLst>
            <pc:docMk/>
            <pc:sldMk cId="3764803325" sldId="424"/>
            <ac:picMk id="20" creationId="{4BE5C509-2941-4F51-A4DC-2002D87DB459}"/>
          </ac:picMkLst>
        </pc:picChg>
        <pc:picChg chg="mod">
          <ac:chgData name="Amedeo Chiribiri" userId="868f9d26-4d40-4615-9aea-e37957f3ff01" providerId="ADAL" clId="{449D9A50-FADE-8342-9437-210282157338}" dt="2025-01-18T14:10:35.248" v="184" actId="18331"/>
          <ac:picMkLst>
            <pc:docMk/>
            <pc:sldMk cId="3764803325" sldId="424"/>
            <ac:picMk id="22" creationId="{3D167DF4-D64A-CF54-555B-AFEC5AA80FBA}"/>
          </ac:picMkLst>
        </pc:picChg>
        <pc:picChg chg="add mod modCrop">
          <ac:chgData name="Amedeo Chiribiri" userId="868f9d26-4d40-4615-9aea-e37957f3ff01" providerId="ADAL" clId="{449D9A50-FADE-8342-9437-210282157338}" dt="2025-01-16T15:49:44.633" v="74" actId="1036"/>
          <ac:picMkLst>
            <pc:docMk/>
            <pc:sldMk cId="3764803325" sldId="424"/>
            <ac:picMk id="29" creationId="{B6CCD962-88D9-FB14-B761-434CEE3ABF40}"/>
          </ac:picMkLst>
        </pc:picChg>
      </pc:sldChg>
      <pc:sldChg chg="del">
        <pc:chgData name="Amedeo Chiribiri" userId="868f9d26-4d40-4615-9aea-e37957f3ff01" providerId="ADAL" clId="{449D9A50-FADE-8342-9437-210282157338}" dt="2025-01-13T19:51:19.871" v="7" actId="2696"/>
        <pc:sldMkLst>
          <pc:docMk/>
          <pc:sldMk cId="3911856009" sldId="424"/>
        </pc:sldMkLst>
      </pc:sldChg>
      <pc:sldChg chg="del">
        <pc:chgData name="Amedeo Chiribiri" userId="868f9d26-4d40-4615-9aea-e37957f3ff01" providerId="ADAL" clId="{449D9A50-FADE-8342-9437-210282157338}" dt="2025-01-13T19:51:19.883" v="8" actId="2696"/>
        <pc:sldMkLst>
          <pc:docMk/>
          <pc:sldMk cId="879764617" sldId="425"/>
        </pc:sldMkLst>
      </pc:sldChg>
      <pc:sldChg chg="del">
        <pc:chgData name="Amedeo Chiribiri" userId="868f9d26-4d40-4615-9aea-e37957f3ff01" providerId="ADAL" clId="{449D9A50-FADE-8342-9437-210282157338}" dt="2025-01-13T19:51:19.859" v="3" actId="2696"/>
        <pc:sldMkLst>
          <pc:docMk/>
          <pc:sldMk cId="3346828519" sldId="427"/>
        </pc:sldMkLst>
      </pc:sldChg>
      <pc:sldChg chg="del">
        <pc:chgData name="Amedeo Chiribiri" userId="868f9d26-4d40-4615-9aea-e37957f3ff01" providerId="ADAL" clId="{449D9A50-FADE-8342-9437-210282157338}" dt="2025-01-13T19:51:19.924" v="9" actId="2696"/>
        <pc:sldMkLst>
          <pc:docMk/>
          <pc:sldMk cId="2693408539" sldId="429"/>
        </pc:sldMkLst>
      </pc:sldChg>
      <pc:sldChg chg="del">
        <pc:chgData name="Amedeo Chiribiri" userId="868f9d26-4d40-4615-9aea-e37957f3ff01" providerId="ADAL" clId="{449D9A50-FADE-8342-9437-210282157338}" dt="2025-01-13T19:51:19.860" v="4" actId="2696"/>
        <pc:sldMkLst>
          <pc:docMk/>
          <pc:sldMk cId="2124251303" sldId="430"/>
        </pc:sldMkLst>
      </pc:sldChg>
      <pc:sldChg chg="del">
        <pc:chgData name="Amedeo Chiribiri" userId="868f9d26-4d40-4615-9aea-e37957f3ff01" providerId="ADAL" clId="{449D9A50-FADE-8342-9437-210282157338}" dt="2025-01-13T19:51:19.857" v="1" actId="2696"/>
        <pc:sldMkLst>
          <pc:docMk/>
          <pc:sldMk cId="1703351904" sldId="43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225CB8-9568-B643-BE78-BE42C2195408}" type="datetimeFigureOut">
              <a:rPr lang="it-IT" smtClean="0"/>
              <a:t>18/01/2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9038A6-EE04-844F-B03F-616BFD37A2C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9025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49038A6-EE04-844F-B03F-616BFD37A2C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87082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card&#10;&#10;Description automatically generated">
            <a:extLst>
              <a:ext uri="{FF2B5EF4-FFF2-40B4-BE49-F238E27FC236}">
                <a16:creationId xmlns:a16="http://schemas.microsoft.com/office/drawing/2014/main" id="{D8F0A4A1-796B-0D39-7C5A-96781E5ECCFE}"/>
              </a:ext>
            </a:extLst>
          </p:cNvPr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12192000" cy="6861574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54628" y="1240688"/>
            <a:ext cx="9144000" cy="2387600"/>
          </a:xfrm>
        </p:spPr>
        <p:txBody>
          <a:bodyPr anchor="b">
            <a:normAutofit/>
          </a:bodyPr>
          <a:lstStyle>
            <a:lvl1pPr algn="ctr">
              <a:defRPr sz="5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4628" y="3720363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dirty="0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1059160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61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761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483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5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108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113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579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636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638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8353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11963-D476-40E8-8DA3-5449844402E2}" type="datetimeFigureOut">
              <a:rPr lang="en-US" smtClean="0"/>
              <a:t>1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28CF2-17BE-480E-9373-9EFE671C63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627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jpeg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95B7EBE-14DF-F4BD-488C-123E4DD3B1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E19E8C0D-F501-957A-CF0C-03C97AFA1D2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30341" y="4251489"/>
            <a:ext cx="2376886" cy="237671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A5941F8-4578-2D22-4952-0572991AB4B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69170" y="4251488"/>
            <a:ext cx="2376714" cy="237671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BE5C509-2941-4F51-A4DC-2002D87DB45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520738" y="4261208"/>
            <a:ext cx="2376715" cy="236699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D167DF4-D64A-CF54-555B-AFEC5AA80FB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91512" y="4251488"/>
            <a:ext cx="2376886" cy="2376714"/>
          </a:xfrm>
          <a:prstGeom prst="rect">
            <a:avLst/>
          </a:prstGeom>
        </p:spPr>
      </p:pic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DBF06B0A-5322-134D-382D-6539431EAC3A}"/>
              </a:ext>
            </a:extLst>
          </p:cNvPr>
          <p:cNvSpPr/>
          <p:nvPr/>
        </p:nvSpPr>
        <p:spPr>
          <a:xfrm>
            <a:off x="1191512" y="836498"/>
            <a:ext cx="2376886" cy="91440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noProof="1"/>
              <a:t>Normal</a:t>
            </a:r>
          </a:p>
        </p:txBody>
      </p: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80F8DEBE-F9E0-CAB6-7359-756583983A6B}"/>
              </a:ext>
            </a:extLst>
          </p:cNvPr>
          <p:cNvSpPr/>
          <p:nvPr/>
        </p:nvSpPr>
        <p:spPr>
          <a:xfrm>
            <a:off x="3630341" y="825615"/>
            <a:ext cx="2376886" cy="91440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noProof="1"/>
              <a:t>Single vessel CAD</a:t>
            </a:r>
          </a:p>
        </p:txBody>
      </p: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ECEB013D-1CE2-4C47-0530-B8FB7AC7F7C0}"/>
              </a:ext>
            </a:extLst>
          </p:cNvPr>
          <p:cNvSpPr/>
          <p:nvPr/>
        </p:nvSpPr>
        <p:spPr>
          <a:xfrm>
            <a:off x="6068998" y="825615"/>
            <a:ext cx="2376886" cy="91440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noProof="1"/>
              <a:t>Multi vessel CAD</a:t>
            </a:r>
          </a:p>
        </p:txBody>
      </p:sp>
      <p:sp>
        <p:nvSpPr>
          <p:cNvPr id="26" name="Rounded Rectangle 25">
            <a:extLst>
              <a:ext uri="{FF2B5EF4-FFF2-40B4-BE49-F238E27FC236}">
                <a16:creationId xmlns:a16="http://schemas.microsoft.com/office/drawing/2014/main" id="{A7659C51-19A9-0D99-A43C-902AEB1DFE1E}"/>
              </a:ext>
            </a:extLst>
          </p:cNvPr>
          <p:cNvSpPr/>
          <p:nvPr/>
        </p:nvSpPr>
        <p:spPr>
          <a:xfrm>
            <a:off x="8507655" y="825615"/>
            <a:ext cx="2376886" cy="91440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noProof="1"/>
              <a:t>Microvascular disease</a:t>
            </a:r>
          </a:p>
          <a:p>
            <a:pPr algn="ctr"/>
            <a:r>
              <a:rPr lang="en-US" noProof="1"/>
              <a:t>(HCM)</a:t>
            </a: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433D5234-ECC9-EB9F-0C79-6BB74FFCA613}"/>
              </a:ext>
            </a:extLst>
          </p:cNvPr>
          <p:cNvSpPr/>
          <p:nvPr/>
        </p:nvSpPr>
        <p:spPr>
          <a:xfrm rot="16200000">
            <a:off x="-515902" y="2552914"/>
            <a:ext cx="2376886" cy="91440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noProof="1"/>
              <a:t>Visual assessment</a:t>
            </a: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A93FD169-2199-3ED3-FC9B-3141D113542E}"/>
              </a:ext>
            </a:extLst>
          </p:cNvPr>
          <p:cNvSpPr/>
          <p:nvPr/>
        </p:nvSpPr>
        <p:spPr>
          <a:xfrm rot="16200000">
            <a:off x="-511128" y="4987505"/>
            <a:ext cx="2366994" cy="914400"/>
          </a:xfrm>
          <a:prstGeom prst="round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noProof="1"/>
              <a:t>Quantitative perfusion map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B0BC7C-9CA8-5C60-5796-2074BA9362F0}"/>
              </a:ext>
            </a:extLst>
          </p:cNvPr>
          <p:cNvSpPr txBox="1"/>
          <p:nvPr/>
        </p:nvSpPr>
        <p:spPr>
          <a:xfrm>
            <a:off x="599550" y="186934"/>
            <a:ext cx="10990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noProof="1"/>
              <a:t>Common patterns observed on perfusion series either by visual assessment or by quantitative perfusion mapping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6CCD962-88D9-FB14-B761-434CEE3ABF4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91512" y="1785372"/>
            <a:ext cx="9705941" cy="247365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836B2EE-462B-D634-5AA8-7128AEBB2897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021003" y="4266130"/>
            <a:ext cx="457200" cy="236207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FF19400-5582-5197-4EB7-FF9CDA172C64}"/>
              </a:ext>
            </a:extLst>
          </p:cNvPr>
          <p:cNvSpPr txBox="1"/>
          <p:nvPr/>
        </p:nvSpPr>
        <p:spPr>
          <a:xfrm>
            <a:off x="10946370" y="3816163"/>
            <a:ext cx="1110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mL/min/g</a:t>
            </a:r>
          </a:p>
        </p:txBody>
      </p:sp>
    </p:spTree>
    <p:extLst>
      <p:ext uri="{BB962C8B-B14F-4D97-AF65-F5344CB8AC3E}">
        <p14:creationId xmlns:p14="http://schemas.microsoft.com/office/powerpoint/2010/main" val="3764803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alibri">
      <a:maj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E43F7E53882F44DAAC752BC6A789EA0" ma:contentTypeVersion="14" ma:contentTypeDescription="Create a new document." ma:contentTypeScope="" ma:versionID="f448d53c60cbb0c6dc21313823a14e3d">
  <xsd:schema xmlns:xsd="http://www.w3.org/2001/XMLSchema" xmlns:xs="http://www.w3.org/2001/XMLSchema" xmlns:p="http://schemas.microsoft.com/office/2006/metadata/properties" xmlns:ns1="http://schemas.microsoft.com/sharepoint/v3" xmlns:ns2="aa03cc6f-dd9f-4f8f-a22b-a6ada83b1f42" xmlns:ns3="8abb83ac-9ede-4336-b906-43098fa69765" targetNamespace="http://schemas.microsoft.com/office/2006/metadata/properties" ma:root="true" ma:fieldsID="5a1f01a6db4609b2f94aa1cecb2de5e8" ns1:_="" ns2:_="" ns3:_="">
    <xsd:import namespace="http://schemas.microsoft.com/sharepoint/v3"/>
    <xsd:import namespace="aa03cc6f-dd9f-4f8f-a22b-a6ada83b1f42"/>
    <xsd:import namespace="8abb83ac-9ede-4336-b906-43098fa69765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1:_ip_UnifiedCompliancePolicyProperties" minOccurs="0"/>
                <xsd:element ref="ns1:_ip_UnifiedCompliancePolicyUIAction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5" nillable="true" ma:displayName="Unified Compliance Policy Properties" ma:description="" ma:hidden="true" ma:internalName="_ip_UnifiedCompliancePolicyProperties">
      <xsd:simpleType>
        <xsd:restriction base="dms:Note"/>
      </xsd:simpleType>
    </xsd:element>
    <xsd:element name="_ip_UnifiedCompliancePolicyUIAction" ma:index="16" nillable="true" ma:displayName="Unified Compliance Policy UI Action" ma:description="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a03cc6f-dd9f-4f8f-a22b-a6ada83b1f42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abb83ac-9ede-4336-b906-43098fa6976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3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4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7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2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FA1FD51-747E-40BA-A838-72C9963328F8}">
  <ds:schemaRefs>
    <ds:schemaRef ds:uri="http://purl.org/dc/elements/1.1/"/>
    <ds:schemaRef ds:uri="http://purl.org/dc/terms/"/>
    <ds:schemaRef ds:uri="http://purl.org/dc/dcmitype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schemas.microsoft.com/sharepoint/v3"/>
    <ds:schemaRef ds:uri="http://www.w3.org/XML/1998/namespace"/>
    <ds:schemaRef ds:uri="8abb83ac-9ede-4336-b906-43098fa69765"/>
    <ds:schemaRef ds:uri="aa03cc6f-dd9f-4f8f-a22b-a6ada83b1f42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ECB35A4A-F79C-4F18-8F4A-0284A21AA72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EC592A8-DB4F-4403-81DB-4626DA2E916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aa03cc6f-dd9f-4f8f-a22b-a6ada83b1f42"/>
    <ds:schemaRef ds:uri="8abb83ac-9ede-4336-b906-43098fa6976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234</TotalTime>
  <Words>38</Words>
  <Application>Microsoft Macintosh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rial</vt:lpstr>
      <vt:lpstr>Calibri</vt:lpstr>
      <vt:lpstr>Office Theme</vt:lpstr>
      <vt:lpstr>PowerPoint Presentation</vt:lpstr>
    </vt:vector>
  </TitlesOfParts>
  <Company>Kellen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Gowan, Brian</dc:creator>
  <cp:lastModifiedBy>Amedeo Chiribiri</cp:lastModifiedBy>
  <cp:revision>126</cp:revision>
  <cp:lastPrinted>2025-01-13T15:16:38Z</cp:lastPrinted>
  <dcterms:created xsi:type="dcterms:W3CDTF">2018-10-31T20:28:47Z</dcterms:created>
  <dcterms:modified xsi:type="dcterms:W3CDTF">2025-01-18T15:14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E43F7E53882F44DAAC752BC6A789EA0</vt:lpwstr>
  </property>
</Properties>
</file>